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67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496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52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287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169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182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853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351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990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195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183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26C9-BBFC-407B-96CD-4E2464D9529D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B01FF-731B-4BB5-B4A4-21D5DE1264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970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26571" y="1287625"/>
            <a:ext cx="8817429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4 Fig. Effect of the alleles and residues on HLA-DRB1 expression.  A. Unconditioned HLA-DRB1 expression. B.</a:t>
            </a:r>
            <a:r>
              <a:rPr lang="en-US" sz="28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b="1" i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LA-DRB1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conditioned on residues </a:t>
            </a:r>
            <a:r>
              <a:rPr lang="en-US" b="1" i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RB1-11+13+37.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. </a:t>
            </a:r>
            <a:r>
              <a:rPr lang="en-US" b="1" i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LA-DRB1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conditioned on 4-digit HLA-DRB1 classical alleles. 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mic position coordinates are presented as </a:t>
            </a:r>
            <a:r>
              <a:rPr lang="en-US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gabases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r the hg19 genomic build. SNPs are presented in black, Residues (AA) are presented in red, and alleles in blue. Lines for genomewide association (P&lt;5x10</a:t>
            </a:r>
            <a:r>
              <a:rPr lang="en-US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8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 red, and for suggestive association (P&lt;5x10</a:t>
            </a:r>
            <a:r>
              <a:rPr lang="en-US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5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in green.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8009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6724" y="1022708"/>
            <a:ext cx="11649456" cy="5543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Rectangle 1"/>
          <p:cNvSpPr/>
          <p:nvPr/>
        </p:nvSpPr>
        <p:spPr>
          <a:xfrm>
            <a:off x="276724" y="0"/>
            <a:ext cx="1191527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a Fig. Effect of the alleles and residues on HLA-DRB1 expression. A. Unconditioned HLA-DRB1 expression. </a:t>
            </a:r>
            <a:r>
              <a:rPr lang="en-US" dirty="0" smtClean="0"/>
              <a:t>Genomic position coordinates are presented as </a:t>
            </a:r>
            <a:r>
              <a:rPr lang="en-US" dirty="0" err="1" smtClean="0"/>
              <a:t>megabases</a:t>
            </a:r>
            <a:r>
              <a:rPr lang="en-US" dirty="0" smtClean="0"/>
              <a:t> for the hg19 genomic build. SNPs are presented in black, Residues (AA) are presented in </a:t>
            </a:r>
            <a:r>
              <a:rPr lang="en-US" dirty="0" smtClean="0">
                <a:solidFill>
                  <a:srgbClr val="FF0000"/>
                </a:solidFill>
              </a:rPr>
              <a:t>red</a:t>
            </a:r>
            <a:r>
              <a:rPr lang="en-US" dirty="0" smtClean="0"/>
              <a:t>, and alleles in </a:t>
            </a:r>
            <a:r>
              <a:rPr lang="en-US" dirty="0" smtClean="0">
                <a:solidFill>
                  <a:srgbClr val="0070C0"/>
                </a:solidFill>
              </a:rPr>
              <a:t>blue</a:t>
            </a:r>
            <a:r>
              <a:rPr lang="en-US" dirty="0" smtClean="0"/>
              <a:t>. Lines for genomewide association (P&lt;5x10</a:t>
            </a:r>
            <a:r>
              <a:rPr lang="en-US" baseline="30000" dirty="0" smtClean="0"/>
              <a:t>-8</a:t>
            </a:r>
            <a:r>
              <a:rPr lang="en-US" dirty="0" smtClean="0"/>
              <a:t>) in red, and for suggestive association (P&lt;5x10</a:t>
            </a:r>
            <a:r>
              <a:rPr lang="en-US" baseline="30000" dirty="0" smtClean="0"/>
              <a:t>-5</a:t>
            </a:r>
            <a:r>
              <a:rPr lang="en-US" dirty="0" smtClean="0"/>
              <a:t>) in green.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3394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325" y="756191"/>
            <a:ext cx="11105148" cy="610180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76724" y="0"/>
            <a:ext cx="1191527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b Fig.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LA-DRB1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conditioned on residues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B1-11+13+37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/>
              <a:t>Genomic position coordinates are presented as </a:t>
            </a:r>
            <a:r>
              <a:rPr lang="en-US" dirty="0" err="1" smtClean="0"/>
              <a:t>megabases</a:t>
            </a:r>
            <a:r>
              <a:rPr lang="en-US" dirty="0" smtClean="0"/>
              <a:t> for the hg19 genomic build. SNPs are presented in black, Residues (AA) are presented in </a:t>
            </a:r>
            <a:r>
              <a:rPr lang="en-US" dirty="0" smtClean="0">
                <a:solidFill>
                  <a:srgbClr val="FF0000"/>
                </a:solidFill>
              </a:rPr>
              <a:t>red</a:t>
            </a:r>
            <a:r>
              <a:rPr lang="en-US" dirty="0" smtClean="0"/>
              <a:t>, and alleles in </a:t>
            </a:r>
            <a:r>
              <a:rPr lang="en-US" dirty="0" smtClean="0">
                <a:solidFill>
                  <a:srgbClr val="0070C0"/>
                </a:solidFill>
              </a:rPr>
              <a:t>blue</a:t>
            </a:r>
            <a:r>
              <a:rPr lang="en-US" dirty="0" smtClean="0"/>
              <a:t>. Lines for genomewide association (P&lt;5x10</a:t>
            </a:r>
            <a:r>
              <a:rPr lang="en-US" baseline="30000" dirty="0" smtClean="0"/>
              <a:t>-8</a:t>
            </a:r>
            <a:r>
              <a:rPr lang="en-US" dirty="0" smtClean="0"/>
              <a:t>) in red, and for suggestive association (P&lt;5x10</a:t>
            </a:r>
            <a:r>
              <a:rPr lang="en-US" baseline="30000" dirty="0" smtClean="0"/>
              <a:t>-5</a:t>
            </a:r>
            <a:r>
              <a:rPr lang="en-US" dirty="0" smtClean="0"/>
              <a:t>) in green.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67779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6724" y="923330"/>
            <a:ext cx="11521440" cy="54825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2"/>
          <p:cNvSpPr/>
          <p:nvPr/>
        </p:nvSpPr>
        <p:spPr>
          <a:xfrm>
            <a:off x="276724" y="0"/>
            <a:ext cx="1191527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c Fig.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LA-DRB1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conditioned on 4-digit HLA-DRB1 classical alleles. </a:t>
            </a:r>
            <a:r>
              <a:rPr lang="en-US" dirty="0" smtClean="0"/>
              <a:t>Genomic position coordinates are presented as </a:t>
            </a:r>
            <a:r>
              <a:rPr lang="en-US" dirty="0" err="1" smtClean="0"/>
              <a:t>megabases</a:t>
            </a:r>
            <a:r>
              <a:rPr lang="en-US" dirty="0" smtClean="0"/>
              <a:t> for the hg19 genomic build. SNPs are presented in black, Residues (AA) are presented in </a:t>
            </a:r>
            <a:r>
              <a:rPr lang="en-US" dirty="0" smtClean="0">
                <a:solidFill>
                  <a:srgbClr val="FF0000"/>
                </a:solidFill>
              </a:rPr>
              <a:t>red</a:t>
            </a:r>
            <a:r>
              <a:rPr lang="en-US" dirty="0" smtClean="0"/>
              <a:t>, and alleles in </a:t>
            </a:r>
            <a:r>
              <a:rPr lang="en-US" dirty="0" smtClean="0">
                <a:solidFill>
                  <a:srgbClr val="0070C0"/>
                </a:solidFill>
              </a:rPr>
              <a:t>blue</a:t>
            </a:r>
            <a:r>
              <a:rPr lang="en-US" dirty="0" smtClean="0"/>
              <a:t>. Lines for genomewide association (P&lt;5x10</a:t>
            </a:r>
            <a:r>
              <a:rPr lang="en-US" baseline="30000" dirty="0" smtClean="0"/>
              <a:t>-8</a:t>
            </a:r>
            <a:r>
              <a:rPr lang="en-US" dirty="0" smtClean="0"/>
              <a:t>) in red, and for suggestive association (P&lt;5x10</a:t>
            </a:r>
            <a:r>
              <a:rPr lang="en-US" baseline="30000" dirty="0" smtClean="0"/>
              <a:t>-5</a:t>
            </a:r>
            <a:r>
              <a:rPr lang="en-US" dirty="0" smtClean="0"/>
              <a:t>) in green.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1414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92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2</cp:revision>
  <dcterms:created xsi:type="dcterms:W3CDTF">2019-03-18T18:28:08Z</dcterms:created>
  <dcterms:modified xsi:type="dcterms:W3CDTF">2019-03-18T18:50:02Z</dcterms:modified>
</cp:coreProperties>
</file>